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78"/>
  </p:normalViewPr>
  <p:slideViewPr>
    <p:cSldViewPr snapToGrid="0">
      <p:cViewPr varScale="1">
        <p:scale>
          <a:sx n="109" d="100"/>
          <a:sy n="109" d="100"/>
        </p:scale>
        <p:origin x="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13D67F-E7DB-932A-1F2C-9D48413F91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E3661D2-B67F-4FDC-C7D7-B11D176D46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F9DF06-DBB2-FDF2-C906-4AB2C42D2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D475DCC-D16E-A9F5-8EAF-888C36A00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17CF36C-11CA-12D3-AA13-74816419E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9130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74D4CDC-8E9E-EA71-6D06-D09BFFCD2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946729F-DFC8-CF5E-BB40-F9B8742172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B06C5F0-A4B9-5BF1-DD12-8341F8557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D1DD922-9F4D-30B8-913E-B7AB97CB8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0E2C85-7E5D-1B66-DEA7-8297E1E3A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481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041A4EE-DA26-3C1C-F1DC-9C49CC4E7D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1B1995A-2CFD-97D4-D18A-7EE7C71431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A618CFF-0DE4-ED4F-9BF3-32A53AD8C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5CFD47E-E649-D18D-0A66-C5F5453B4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2A24E88-7015-A5E7-66A2-D62C684B3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3306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A9932E-6C06-956E-9DFF-324289F959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EBB4A54-65A1-E917-E425-25F95F2116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071166-E4DC-0FFB-89E9-9729B6165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A792CE3-480E-AED3-071B-FBD7DCA8F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D1D7C4C-079D-9F55-990A-9F658CF9F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1525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89F300-E19E-FDAA-1B2F-BA65DEDB8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8D5BCD9-B56A-9A79-EA9B-C2CBEED56F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B9637F3-EDCC-33CA-01D7-F175DA474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BA7DBDB-BC15-EB80-B21C-9F1805CA9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48E8990-9110-1C72-42CE-FD0916157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418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9204F0-85C4-677C-AB60-85A7211E4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0A5DFF5-1221-7EEF-1B49-420C49AA67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E7E8E9E-AAFD-9A2A-9DEB-B1EC34E19E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DB7D284-7688-7079-FED6-EDC95347E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3D22D6C-720F-EF08-E47A-DF86E8AD5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1AD078C-565F-533E-DF7A-15F1E47B9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1086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F7DF72-6DD1-FF6F-5F3D-9DC1DCFF0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4B146B4-C02E-EC49-3818-911BA9CBE0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3A1981A-E3CA-95E6-D144-4C08E1CC4A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743277F-AB90-1194-2803-E9A8B8FE8B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B626FDE-D966-8A78-1402-9957F5997F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8B8C862-B3F6-725D-2298-EDC0FCED90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45466EF-5B53-43CD-DDED-BA9DAD0CB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E1071F7-9D13-E9A6-A1DE-147A2B667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701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D1DFCD-685E-1564-475F-5998269F93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CB1C099-388A-7336-7EC8-D69ABCD6C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C2F7F58-0C49-9E8A-E343-CA2D07667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169FA4A-5A00-4679-C046-0CFEC894A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5846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087FA22-23DE-7E79-1DAB-3CF7480B2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085EFBE-7D05-0842-E58A-6BEACA895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7B8D634-CD79-B2E4-D191-EB560BCAB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01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4F01E8-8719-1958-FCD4-483C80487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192E575-0E03-4B0F-7BA3-B3FAD78E04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574F64D-49FB-8BAC-5517-FF2D8177A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5483C2F-1EFD-4ACD-4F6F-C102F538F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6ED90CF-03ED-365A-1D44-77D9FFF4F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375CD6D-42F0-2B18-270B-4B561BCEE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9674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3685620-3509-E181-25F8-059363378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C279EF6-2648-9EE1-E789-8873E93A4C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8295A8A-7CA3-ECB3-88B2-FCBF2EF073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0008F94-0D09-2A28-1126-8687559B6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EE8C4DA-C1E4-CE50-7255-3829272F4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1145D88-7EB2-F135-1548-513796EE8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082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1C36184-58FB-CDF0-9100-2FC4DEC97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A71D762-B5C5-1D45-B493-E2349963DD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14B8707-2F59-17AE-E0D4-BDEDEAF854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A9C05-F834-E64D-B521-76D2A5B8E321}" type="datetimeFigureOut">
              <a:rPr lang="en-GB" smtClean="0"/>
              <a:t>19/05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AF5832-3200-22B6-2D0F-64091DD179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522DF9E-C763-9B54-1AE2-4554F90CA9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D1F4B-BC03-1B4C-9342-7AD56B071CD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57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F8A280F0-365D-B7DA-B0B2-50A83A380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600" y="130126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56A7F211-532A-2A8B-3A98-7F15A3E515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8738071"/>
              </p:ext>
            </p:extLst>
          </p:nvPr>
        </p:nvGraphicFramePr>
        <p:xfrm>
          <a:off x="736600" y="1587498"/>
          <a:ext cx="5359400" cy="5118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7835900" imgH="7518400" progId="Prism8.Document">
                  <p:embed/>
                </p:oleObj>
              </mc:Choice>
              <mc:Fallback>
                <p:oleObj r:id="rId2" imgW="7835900" imgH="7518400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36600" y="1587498"/>
                        <a:ext cx="5359400" cy="5118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B3BABD4C-0F76-8CDA-40FD-061F341CEEE9}"/>
              </a:ext>
            </a:extLst>
          </p:cNvPr>
          <p:cNvSpPr txBox="1"/>
          <p:nvPr/>
        </p:nvSpPr>
        <p:spPr>
          <a:xfrm>
            <a:off x="444730" y="383417"/>
            <a:ext cx="10716395" cy="1309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656080" algn="just">
              <a:lnSpc>
                <a:spcPct val="95000"/>
              </a:lnSpc>
              <a:spcAft>
                <a:spcPts val="6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Materials</a:t>
            </a:r>
            <a:endParaRPr lang="it-IT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  <a:spcBef>
                <a:spcPts val="1200"/>
              </a:spcBef>
            </a:pPr>
            <a:r>
              <a:rPr lang="en-US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lavonoid Fraction of the Bergamot (</a:t>
            </a:r>
            <a:r>
              <a:rPr lang="en-US" sz="1400" b="1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itrus bergamia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Peel and Juice Extract Protects Human Red Blood Cells from Natural Aging</a:t>
            </a:r>
            <a:endParaRPr lang="it-IT" sz="14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71755" algn="just">
              <a:lnSpc>
                <a:spcPts val="1200"/>
              </a:lnSpc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it-IT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marR="71755" lvl="0" indent="-342900" algn="just">
              <a:lnSpc>
                <a:spcPts val="1200"/>
              </a:lnSpc>
              <a:buFont typeface="+mj-lt"/>
              <a:buAutoNum type="arabicPeriod"/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endParaRPr lang="it-IT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40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6688734-3C12-CB86-A1E0-300EA1B2ACBA}"/>
              </a:ext>
            </a:extLst>
          </p:cNvPr>
          <p:cNvSpPr txBox="1"/>
          <p:nvPr/>
        </p:nvSpPr>
        <p:spPr>
          <a:xfrm>
            <a:off x="6213231" y="1693006"/>
            <a:ext cx="4585673" cy="4508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  <a:spcBef>
                <a:spcPts val="1200"/>
              </a:spcBef>
            </a:pP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1.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Effect of increasing concentrations of peel extract on </a:t>
            </a:r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aemolysis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TBARS levels, and sulfhydryl groups total content.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B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aemolysis measurement. Human RBCs have been exposed to increasing concentrations of peel extract for 15 min, or alternatively, for 1 h and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. Complete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aemolysi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was obtained with distilled water (d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). ns, not statistically significant versus control; *** p&lt; 0.001 versus control (untreated), ANOVA with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unnet’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post-test (n=10).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E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oxidative stress assessment by estimation of TBARS levels.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uman RBCs have been exposed to increasing concentrations of peel extract for 15 min, 1 h and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 or to 20 mM 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s the positive control. ns, not statistically significant versus control (untreated); *** p&lt; 0.001 versus control, ANOVA with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unnet’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post-test (n=10).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G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 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d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I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oxidative stress assessment by estimation of total sulfhydryl group content (µM TNB/µg protein).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uman RBCs have been exposed to increasing concentrations of peel extract for 15 min, or alternatively, for 1 h and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 or to 20 mM 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s the positive control. ns, not statistically significant versus control; *** p&lt; 0.001 versus control (untreated), ANOVA with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unnet’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post-test (n=10).</a:t>
            </a:r>
            <a:endParaRPr lang="it-IT" sz="20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398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17FE693B-5766-6941-E888-FA3189F975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700" y="6540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F327D05F-5915-931F-F602-8AB389B357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3075800"/>
              </p:ext>
            </p:extLst>
          </p:nvPr>
        </p:nvGraphicFramePr>
        <p:xfrm>
          <a:off x="393700" y="654050"/>
          <a:ext cx="5702300" cy="554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7835900" imgH="7581900" progId="Prism8.Document">
                  <p:embed/>
                </p:oleObj>
              </mc:Choice>
              <mc:Fallback>
                <p:oleObj r:id="rId2" imgW="7835900" imgH="7581900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3700" y="654050"/>
                        <a:ext cx="5702300" cy="55499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F47DFAC9-80DD-2178-E0B0-813FFB2736CE}"/>
              </a:ext>
            </a:extLst>
          </p:cNvPr>
          <p:cNvSpPr txBox="1"/>
          <p:nvPr/>
        </p:nvSpPr>
        <p:spPr>
          <a:xfrm>
            <a:off x="6224954" y="1527564"/>
            <a:ext cx="5076093" cy="40656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  <a:spcBef>
                <a:spcPts val="1200"/>
              </a:spcBef>
            </a:pP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2.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Effect of increasing concentrations of juice extract on </a:t>
            </a:r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aemolysis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TBARS levels, and sulfhydryl groups total content.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B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aemolysis measurement. Human RBCs have been exposed to increasing concentrations of juice extract for 15 min, or alternatively, for 1 h and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. Complete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aemolysi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was obtained with distilled water (d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). ns, not statistically significant versus control (untreated); *** p&lt; 0.01 versus control, ANOVA with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unnet’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post-test (n=10).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E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oxidative stress assessment by estimation of TBARS levels.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uman RBCs have been exposed to increasing concentrations of juice extract for 15 min, 1 h and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 or to 20 mM 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s the positive control. ns, not statistically significant versus control (untreated); ** p&lt; 0.01 and *** p&lt; 0.01 versus control, ANOVA with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unnet’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post-test (n=10).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G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I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oxidative stress assessment by estimation of total sulfhydryl group content (µM TNB/µg protein).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uman RBCs have been exposed to increasing concentrations of juice extract for 15 min, or alternatively, for 1 h and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 or to 20 mM 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s the positive control. ns, not statistically significant versus control (untreated); *** p&lt;0.001 versus control, ANOVA with </a:t>
            </a:r>
            <a:r>
              <a:rPr lang="en-US" sz="1200" b="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unnet’s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post-test (n=10).</a:t>
            </a:r>
            <a:endParaRPr lang="it-IT" sz="20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9963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BD0D695D-98FC-029B-6D17-AED873ECA4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4462" y="5275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0A09E51D-6E87-E1AD-E905-FB8C606076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7196162"/>
              </p:ext>
            </p:extLst>
          </p:nvPr>
        </p:nvGraphicFramePr>
        <p:xfrm>
          <a:off x="602762" y="527538"/>
          <a:ext cx="5727700" cy="187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9880600" imgH="3238500" progId="Prism8.Document">
                  <p:embed/>
                </p:oleObj>
              </mc:Choice>
              <mc:Fallback>
                <p:oleObj r:id="rId2" imgW="9880600" imgH="3238500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02762" y="527538"/>
                        <a:ext cx="5727700" cy="18796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4">
            <a:extLst>
              <a:ext uri="{FF2B5EF4-FFF2-40B4-BE49-F238E27FC236}">
                <a16:creationId xmlns:a16="http://schemas.microsoft.com/office/drawing/2014/main" id="{E8AF5BA7-0B62-0E67-4934-0C24DAF588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3908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E45F00E2-D7B4-DA86-42CF-2327B60153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9794909"/>
              </p:ext>
            </p:extLst>
          </p:nvPr>
        </p:nvGraphicFramePr>
        <p:xfrm>
          <a:off x="6506308" y="139700"/>
          <a:ext cx="4787900" cy="657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4902200" imgH="6781800" progId="Prism8.Document">
                  <p:embed/>
                </p:oleObj>
              </mc:Choice>
              <mc:Fallback>
                <p:oleObj r:id="rId4" imgW="4902200" imgH="6781800" progId="Prism8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506308" y="139700"/>
                        <a:ext cx="4787900" cy="65786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2D28E334-BB2F-7029-5B4B-F412E182D349}"/>
              </a:ext>
            </a:extLst>
          </p:cNvPr>
          <p:cNvSpPr txBox="1"/>
          <p:nvPr/>
        </p:nvSpPr>
        <p:spPr>
          <a:xfrm>
            <a:off x="602762" y="2556895"/>
            <a:ext cx="6096000" cy="3400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  <a:spcBef>
                <a:spcPts val="1200"/>
              </a:spcBef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3.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tioxidant Capacity Estimation of Peel and/or Juice Extrac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. 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uman RBCs have been exposed to 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100 mM D-Gal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for 24 h at 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5 °C</a:t>
            </a:r>
            <a:r>
              <a:rPr lang="en-GB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with or without increasing concentrations of peel or juice extract for 15 min, 1 h, or alternatively, 3 h at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37 °C.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D 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d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E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Oxidative stress assessment by estimation of ROS levels. 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(20 mM) was used as the positive control. ns, not statistically significant versus control (untreated); * p&lt;0.05 and *** p&lt; 0.001 versus control; ° p&lt;0.05, °° p&lt;0.01 and °°° p&lt; 0.001 versus 100 mM D-Gal, ANOVA followed by Bonferroni’s multiple comparison post-test (n=9);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B, G 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d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F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estimation of TBARS levels. H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O</a:t>
            </a:r>
            <a:r>
              <a:rPr lang="en-US" sz="1200" b="0" baseline="-25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(20 mM) was used as the positive control. ns, not statistically significant versus control (untreated); *** p&lt; 0.001 versus control; °° p&lt;0.01 and °°° p&lt; 0.001 versus 100 mM D-Gal, ANOVA followed by Bonferroni’s multiple comparison post-test (n=9);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 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d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I</a:t>
            </a:r>
            <a:r>
              <a:rPr lang="en-US" sz="1200" b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estimation of total sulfhydryl group content (µM TNB/µg protein). NEM (2 mM) was used as the positive control. ns, not statistically significant versus control (untreated); *p&lt;0.05, **p&lt;0.01 and ***p&lt;0.001 versus control, ° p&lt;0.05 and °°° p&lt;0.001 versus 100 mM D-Gal, ANOVA followed by Bonferroni’s multiple comparison post-test (n=9).</a:t>
            </a:r>
            <a:endParaRPr lang="it-IT" sz="20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2651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1A992F4B-0FF3-E8B8-1E92-B5CBE07148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5785" y="10160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2F1390FD-610D-1EA3-BC2F-AA343C86A3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6391263"/>
              </p:ext>
            </p:extLst>
          </p:nvPr>
        </p:nvGraphicFramePr>
        <p:xfrm>
          <a:off x="855785" y="1016000"/>
          <a:ext cx="3340100" cy="2413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4508500" imgH="3238500" progId="Prism8.Document">
                  <p:embed/>
                </p:oleObj>
              </mc:Choice>
              <mc:Fallback>
                <p:oleObj r:id="rId2" imgW="4508500" imgH="3238500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55785" y="1016000"/>
                        <a:ext cx="3340100" cy="24130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9945EA66-93DD-3F52-1844-5ABF0705AAF1}"/>
              </a:ext>
            </a:extLst>
          </p:cNvPr>
          <p:cNvSpPr txBox="1"/>
          <p:nvPr/>
        </p:nvSpPr>
        <p:spPr>
          <a:xfrm>
            <a:off x="-1122485" y="3751351"/>
            <a:ext cx="10454054" cy="7063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igure S4. Time course of SO</a:t>
            </a:r>
            <a:r>
              <a:rPr lang="en-US" sz="1400" b="1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4</a:t>
            </a:r>
            <a:r>
              <a:rPr lang="en-US" sz="14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2-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uptake.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Red blood cells were untreated (control) or treated with 5 µg/mL of peel or juice extract for 15 min at 37 °C, or 10 µM DIDS. ns, not statistically significant versus untreated (control); *** p&lt;0.001 versus control; ANOVA with </a:t>
            </a:r>
            <a:r>
              <a:rPr lang="en-US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Dunnet’s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post-test (n=15).</a:t>
            </a:r>
            <a:endParaRPr lang="it-IT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8152860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08</Words>
  <Application>Microsoft Macintosh PowerPoint</Application>
  <PresentationFormat>Widescreen</PresentationFormat>
  <Paragraphs>8</Paragraphs>
  <Slides>4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Tema di Office</vt:lpstr>
      <vt:lpstr>Prism8.Docume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IA REMIGANTE</dc:creator>
  <cp:lastModifiedBy>ALESSIA REMIGANTE</cp:lastModifiedBy>
  <cp:revision>3</cp:revision>
  <dcterms:created xsi:type="dcterms:W3CDTF">2023-05-19T09:52:59Z</dcterms:created>
  <dcterms:modified xsi:type="dcterms:W3CDTF">2023-05-19T09:57:28Z</dcterms:modified>
</cp:coreProperties>
</file>